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7" y="6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84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91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06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478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84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938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68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940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84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34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102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457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V="1">
            <a:off x="1218370" y="1404851"/>
            <a:ext cx="2111434" cy="1662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532721" y="1421477"/>
            <a:ext cx="2128244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053244" y="1039089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aline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46" y="2459449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-GSK3</a:t>
            </a:r>
            <a:r>
              <a:rPr lang="el-GR" dirty="0" smtClean="0"/>
              <a:t>β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893129" y="1050168"/>
            <a:ext cx="97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icotine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7450052" y="1338349"/>
            <a:ext cx="1770611" cy="8313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9462653" y="1341122"/>
            <a:ext cx="1770611" cy="8313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633841" y="991978"/>
            <a:ext cx="1263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aline+NAC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9573481" y="994751"/>
            <a:ext cx="1490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Nicotine+NAC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82417" y="479585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893070" y="2644111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887532" y="4988835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7030621" y="2667346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292717" y="497224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7097832" y="5136648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136116" y="66675"/>
            <a:ext cx="95846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The original blot images which we generated for Figure 6A.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5308932"/>
              </p:ext>
            </p:extLst>
          </p:nvPr>
        </p:nvGraphicFramePr>
        <p:xfrm>
          <a:off x="1228992" y="4174447"/>
          <a:ext cx="4608275" cy="210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Image" r:id="rId3" imgW="4714200" imgH="2104560" progId="Photoshop.Image.13">
                  <p:embed/>
                </p:oleObj>
              </mc:Choice>
              <mc:Fallback>
                <p:oleObj name="Image" r:id="rId3" imgW="4714200" imgH="21045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28992" y="4174447"/>
                        <a:ext cx="4608275" cy="210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498676"/>
              </p:ext>
            </p:extLst>
          </p:nvPr>
        </p:nvGraphicFramePr>
        <p:xfrm>
          <a:off x="7348452" y="1404851"/>
          <a:ext cx="4014874" cy="2276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Image" r:id="rId5" imgW="5685480" imgH="2275920" progId="Photoshop.Image.13">
                  <p:embed/>
                </p:oleObj>
              </mc:Choice>
              <mc:Fallback>
                <p:oleObj name="Image" r:id="rId5" imgW="5685480" imgH="22759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348452" y="1404851"/>
                        <a:ext cx="4014874" cy="2276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6071553" y="2500636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-GSK3</a:t>
            </a:r>
            <a:r>
              <a:rPr lang="el-GR" dirty="0" smtClean="0"/>
              <a:t>β</a:t>
            </a:r>
            <a:endParaRPr lang="en-US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3688577"/>
              </p:ext>
            </p:extLst>
          </p:nvPr>
        </p:nvGraphicFramePr>
        <p:xfrm>
          <a:off x="1228992" y="1471525"/>
          <a:ext cx="4551829" cy="2143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Image" r:id="rId7" imgW="5657040" imgH="2142720" progId="Photoshop.Image.13">
                  <p:embed/>
                </p:oleObj>
              </mc:Choice>
              <mc:Fallback>
                <p:oleObj name="Image" r:id="rId7" imgW="5657040" imgH="21427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28992" y="1471525"/>
                        <a:ext cx="4551829" cy="2143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0508389"/>
              </p:ext>
            </p:extLst>
          </p:nvPr>
        </p:nvGraphicFramePr>
        <p:xfrm>
          <a:off x="7348451" y="4376630"/>
          <a:ext cx="4132349" cy="14776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Image" r:id="rId9" imgW="5380920" imgH="1694880" progId="Photoshop.Image.13">
                  <p:embed/>
                </p:oleObj>
              </mc:Choice>
              <mc:Fallback>
                <p:oleObj name="Image" r:id="rId9" imgW="5380920" imgH="16948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48451" y="4376630"/>
                        <a:ext cx="4132349" cy="14776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5" name="Straight Connector 24"/>
          <p:cNvCxnSpPr/>
          <p:nvPr/>
        </p:nvCxnSpPr>
        <p:spPr>
          <a:xfrm>
            <a:off x="3464987" y="1207911"/>
            <a:ext cx="0" cy="507156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9374724" y="1145820"/>
            <a:ext cx="0" cy="507156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3302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2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Loma Linda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, Daliao (LLU)</dc:creator>
  <cp:lastModifiedBy>Xiao, Daliao (LLU)</cp:lastModifiedBy>
  <cp:revision>11</cp:revision>
  <dcterms:created xsi:type="dcterms:W3CDTF">2015-12-16T17:26:50Z</dcterms:created>
  <dcterms:modified xsi:type="dcterms:W3CDTF">2015-12-17T23:17:01Z</dcterms:modified>
</cp:coreProperties>
</file>